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179D3-471B-4723-A34D-6FBE0A386E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DEB10-57FA-4215-BC1F-DB5E54EE64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1719B-F212-4FFD-82C5-1F4BA6D5F6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57DF3-5531-4874-8E88-C00ED3A22A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A1F4E-DB5A-4E0C-9A04-5DD526DF10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7B5AB-C6C9-4E35-8BB2-66727073C7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862A9-3077-4FDD-8C91-5497B3DC5C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F0011-51BC-406E-AB65-FA58037084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C09E9-20C2-4BBA-8A0F-A05242CBD6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679F9-9715-4A80-9FE7-3BF77A28F5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9B63A-C2E0-43C8-A586-2AA2955713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B66BF-7C7A-4395-A6FE-FB7B471C61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5A6C56-F13F-4B1C-95AC-C6D83EC19C6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3.png"/><Relationship Id="rId6" Type="http://schemas.openxmlformats.org/officeDocument/2006/relationships/image" Target="../media/image1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500040" y="1004760"/>
            <a:ext cx="8190000" cy="3897360"/>
            <a:chOff x="500040" y="1004760"/>
            <a:chExt cx="8190000" cy="3897360"/>
          </a:xfrm>
        </p:grpSpPr>
        <p:grpSp>
          <p:nvGrpSpPr>
            <p:cNvPr id="42" name="Rectangle 7"/>
            <p:cNvGrpSpPr/>
            <p:nvPr/>
          </p:nvGrpSpPr>
          <p:grpSpPr>
            <a:xfrm>
              <a:off x="1901160" y="1004760"/>
              <a:ext cx="2590560" cy="717840"/>
              <a:chOff x="1901160" y="1004760"/>
              <a:chExt cx="2590560" cy="717840"/>
            </a:xfrm>
          </p:grpSpPr>
          <p:pic>
            <p:nvPicPr>
              <p:cNvPr id="43" name="Rectangle 7" descr=""/>
              <p:cNvPicPr/>
              <p:nvPr/>
            </p:nvPicPr>
            <p:blipFill>
              <a:blip r:embed="rId1"/>
              <a:stretch/>
            </p:blipFill>
            <p:spPr>
              <a:xfrm>
                <a:off x="1901160" y="1004760"/>
                <a:ext cx="2590560" cy="71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1924920" y="102816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496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Diagnosed with primary invasive breast cancer (2004-2011)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379,10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5" name="Rectangle 9"/>
            <p:cNvGrpSpPr/>
            <p:nvPr/>
          </p:nvGrpSpPr>
          <p:grpSpPr>
            <a:xfrm>
              <a:off x="1901160" y="2060640"/>
              <a:ext cx="2590560" cy="723960"/>
              <a:chOff x="1901160" y="2060640"/>
              <a:chExt cx="2590560" cy="723960"/>
            </a:xfrm>
          </p:grpSpPr>
          <p:pic>
            <p:nvPicPr>
              <p:cNvPr id="46" name="Rectangle 9" descr=""/>
              <p:cNvPicPr/>
              <p:nvPr/>
            </p:nvPicPr>
            <p:blipFill>
              <a:blip r:embed="rId2"/>
              <a:stretch/>
            </p:blipFill>
            <p:spPr>
              <a:xfrm>
                <a:off x="1901160" y="2060640"/>
                <a:ext cx="2590560" cy="723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"/>
              <p:cNvSpPr/>
              <p:nvPr/>
            </p:nvSpPr>
            <p:spPr>
              <a:xfrm>
                <a:off x="1924920" y="208620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496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HR-positive, non-metastatic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272,93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8" name="Rectangle 11"/>
            <p:cNvGrpSpPr/>
            <p:nvPr/>
          </p:nvGrpSpPr>
          <p:grpSpPr>
            <a:xfrm>
              <a:off x="3302640" y="3122280"/>
              <a:ext cx="2590560" cy="717840"/>
              <a:chOff x="3302640" y="3122280"/>
              <a:chExt cx="2590560" cy="717840"/>
            </a:xfrm>
          </p:grpSpPr>
          <p:pic>
            <p:nvPicPr>
              <p:cNvPr id="49" name="Rectangle 11" descr=""/>
              <p:cNvPicPr/>
              <p:nvPr/>
            </p:nvPicPr>
            <p:blipFill>
              <a:blip r:embed="rId3"/>
              <a:stretch/>
            </p:blipFill>
            <p:spPr>
              <a:xfrm>
                <a:off x="3302640" y="3122280"/>
                <a:ext cx="2590560" cy="71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"/>
              <p:cNvSpPr/>
              <p:nvPr/>
            </p:nvSpPr>
            <p:spPr>
              <a:xfrm>
                <a:off x="3325320" y="314424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784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ode-negativ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184,19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1" name="Rectangle 13"/>
            <p:cNvGrpSpPr/>
            <p:nvPr/>
          </p:nvGrpSpPr>
          <p:grpSpPr>
            <a:xfrm>
              <a:off x="6099480" y="3122280"/>
              <a:ext cx="2590560" cy="717840"/>
              <a:chOff x="6099480" y="3122280"/>
              <a:chExt cx="2590560" cy="717840"/>
            </a:xfrm>
          </p:grpSpPr>
          <p:pic>
            <p:nvPicPr>
              <p:cNvPr id="52" name="Rectangle 13" descr=""/>
              <p:cNvPicPr/>
              <p:nvPr/>
            </p:nvPicPr>
            <p:blipFill>
              <a:blip r:embed="rId4"/>
              <a:stretch/>
            </p:blipFill>
            <p:spPr>
              <a:xfrm>
                <a:off x="6099480" y="3122280"/>
                <a:ext cx="2590560" cy="71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"/>
              <p:cNvSpPr/>
              <p:nvPr/>
            </p:nvSpPr>
            <p:spPr>
              <a:xfrm>
                <a:off x="6126120" y="314424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784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Age 40-84 years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169,158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4" name="Rectangle 21"/>
            <p:cNvGrpSpPr/>
            <p:nvPr/>
          </p:nvGrpSpPr>
          <p:grpSpPr>
            <a:xfrm>
              <a:off x="6099480" y="4178160"/>
              <a:ext cx="2590560" cy="723960"/>
              <a:chOff x="6099480" y="4178160"/>
              <a:chExt cx="2590560" cy="723960"/>
            </a:xfrm>
          </p:grpSpPr>
          <p:pic>
            <p:nvPicPr>
              <p:cNvPr id="55" name="Rectangle 21" descr=""/>
              <p:cNvPicPr/>
              <p:nvPr/>
            </p:nvPicPr>
            <p:blipFill>
              <a:blip r:embed="rId5"/>
              <a:stretch/>
            </p:blipFill>
            <p:spPr>
              <a:xfrm>
                <a:off x="6099480" y="4178160"/>
                <a:ext cx="2590560" cy="723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"/>
              <p:cNvSpPr/>
              <p:nvPr/>
            </p:nvSpPr>
            <p:spPr>
              <a:xfrm>
                <a:off x="6126120" y="420228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784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With Recurrence Score results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ode-negative, age 40-84 years</a:t>
                </a:r>
                <a:br>
                  <a:rPr sz="1400"/>
                </a:b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38,568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57" name="Straight Arrow Connector 27"/>
            <p:cNvCxnSpPr>
              <a:stCxn id="43" idx="2"/>
              <a:endCxn id="46" idx="0"/>
            </p:cNvCxnSpPr>
            <p:nvPr/>
          </p:nvCxnSpPr>
          <p:spPr>
            <a:xfrm>
              <a:off x="3196440" y="1722600"/>
              <a:ext cx="360" cy="3384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cxnSp>
          <p:nvCxnSpPr>
            <p:cNvPr id="58" name="Straight Arrow Connector 31"/>
            <p:cNvCxnSpPr>
              <a:stCxn id="49" idx="2"/>
              <a:endCxn id="59" idx="0"/>
            </p:cNvCxnSpPr>
            <p:nvPr/>
          </p:nvCxnSpPr>
          <p:spPr>
            <a:xfrm>
              <a:off x="4597920" y="3840120"/>
              <a:ext cx="360" cy="344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cxnSp>
          <p:nvCxnSpPr>
            <p:cNvPr id="60" name="Straight Arrow Connector 38"/>
            <p:cNvCxnSpPr>
              <a:stCxn id="52" idx="2"/>
              <a:endCxn id="55" idx="0"/>
            </p:cNvCxnSpPr>
            <p:nvPr/>
          </p:nvCxnSpPr>
          <p:spPr>
            <a:xfrm>
              <a:off x="7394760" y="3840120"/>
              <a:ext cx="360" cy="3384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cxnSp>
          <p:nvCxnSpPr>
            <p:cNvPr id="61" name="Straight Arrow Connector 42"/>
            <p:cNvCxnSpPr>
              <a:stCxn id="49" idx="3"/>
              <a:endCxn id="52" idx="1"/>
            </p:cNvCxnSpPr>
            <p:nvPr/>
          </p:nvCxnSpPr>
          <p:spPr>
            <a:xfrm>
              <a:off x="5893200" y="3481200"/>
              <a:ext cx="206640" cy="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grpSp>
          <p:nvGrpSpPr>
            <p:cNvPr id="62" name="Rectangle 20"/>
            <p:cNvGrpSpPr/>
            <p:nvPr/>
          </p:nvGrpSpPr>
          <p:grpSpPr>
            <a:xfrm>
              <a:off x="500040" y="3122280"/>
              <a:ext cx="2590560" cy="717840"/>
              <a:chOff x="500040" y="3122280"/>
              <a:chExt cx="2590560" cy="717840"/>
            </a:xfrm>
          </p:grpSpPr>
          <p:pic>
            <p:nvPicPr>
              <p:cNvPr id="63" name="Rectangle 20" descr=""/>
              <p:cNvPicPr/>
              <p:nvPr/>
            </p:nvPicPr>
            <p:blipFill>
              <a:blip r:embed="rId6"/>
              <a:stretch/>
            </p:blipFill>
            <p:spPr>
              <a:xfrm>
                <a:off x="500040" y="3122280"/>
                <a:ext cx="2590560" cy="71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"/>
              <p:cNvSpPr/>
              <p:nvPr/>
            </p:nvSpPr>
            <p:spPr>
              <a:xfrm>
                <a:off x="524520" y="314424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784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ode-positive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[N+(mic,1-3)]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57,49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65" name="Elbow Connector 14"/>
            <p:cNvCxnSpPr>
              <a:stCxn id="46" idx="2"/>
              <a:endCxn id="49" idx="0"/>
            </p:cNvCxnSpPr>
            <p:nvPr/>
          </p:nvCxnSpPr>
          <p:spPr>
            <a:xfrm flipH="1" rot="16200000">
              <a:off x="3728160" y="2252520"/>
              <a:ext cx="338040" cy="1401840"/>
            </a:xfrm>
            <a:prstGeom prst="bentConnector3">
              <a:avLst>
                <a:gd name="adj1" fmla="val 50000"/>
              </a:avLst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cxnSp>
          <p:nvCxnSpPr>
            <p:cNvPr id="66" name="Elbow Connector 24"/>
            <p:cNvCxnSpPr>
              <a:stCxn id="46" idx="2"/>
              <a:endCxn id="63" idx="0"/>
            </p:cNvCxnSpPr>
            <p:nvPr/>
          </p:nvCxnSpPr>
          <p:spPr>
            <a:xfrm rot="5400000">
              <a:off x="2327040" y="2252880"/>
              <a:ext cx="338040" cy="1401480"/>
            </a:xfrm>
            <a:prstGeom prst="bentConnector3">
              <a:avLst>
                <a:gd name="adj1" fmla="val 50000"/>
              </a:avLst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grpSp>
          <p:nvGrpSpPr>
            <p:cNvPr id="67" name="Rectangle 37"/>
            <p:cNvGrpSpPr/>
            <p:nvPr/>
          </p:nvGrpSpPr>
          <p:grpSpPr>
            <a:xfrm>
              <a:off x="500040" y="4178160"/>
              <a:ext cx="2590560" cy="723960"/>
              <a:chOff x="500040" y="4178160"/>
              <a:chExt cx="2590560" cy="723960"/>
            </a:xfrm>
          </p:grpSpPr>
          <p:pic>
            <p:nvPicPr>
              <p:cNvPr id="68" name="Rectangle 37" descr=""/>
              <p:cNvPicPr/>
              <p:nvPr/>
            </p:nvPicPr>
            <p:blipFill>
              <a:blip r:embed="rId7"/>
              <a:stretch/>
            </p:blipFill>
            <p:spPr>
              <a:xfrm>
                <a:off x="500040" y="4178160"/>
                <a:ext cx="2590560" cy="723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9" name=""/>
              <p:cNvSpPr/>
              <p:nvPr/>
            </p:nvSpPr>
            <p:spPr>
              <a:xfrm>
                <a:off x="524520" y="420228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784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With Recurrence Score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results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br>
                  <a:rPr sz="1400"/>
                </a:b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ode-positive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[N+(mic,1-3)]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4,69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70" name="Straight Arrow Connector 39"/>
            <p:cNvCxnSpPr>
              <a:stCxn id="63" idx="2"/>
              <a:endCxn id="68" idx="0"/>
            </p:cNvCxnSpPr>
            <p:nvPr/>
          </p:nvCxnSpPr>
          <p:spPr>
            <a:xfrm>
              <a:off x="1795320" y="3840120"/>
              <a:ext cx="360" cy="3384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  <p:grpSp>
          <p:nvGrpSpPr>
            <p:cNvPr id="71" name="Rectangle 32"/>
            <p:cNvGrpSpPr/>
            <p:nvPr/>
          </p:nvGrpSpPr>
          <p:grpSpPr>
            <a:xfrm>
              <a:off x="3302640" y="4184280"/>
              <a:ext cx="2590560" cy="717840"/>
              <a:chOff x="3302640" y="4184280"/>
              <a:chExt cx="2590560" cy="717840"/>
            </a:xfrm>
          </p:grpSpPr>
          <p:pic>
            <p:nvPicPr>
              <p:cNvPr id="72" name="Rectangle 32" descr=""/>
              <p:cNvPicPr/>
              <p:nvPr/>
            </p:nvPicPr>
            <p:blipFill>
              <a:blip r:embed="rId8"/>
              <a:stretch/>
            </p:blipFill>
            <p:spPr>
              <a:xfrm>
                <a:off x="3302640" y="4184280"/>
                <a:ext cx="2590560" cy="71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3" name=""/>
              <p:cNvSpPr/>
              <p:nvPr/>
            </p:nvSpPr>
            <p:spPr>
              <a:xfrm>
                <a:off x="3325320" y="4205520"/>
                <a:ext cx="2548440" cy="67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87840" bIns="84960" anchor="ctr">
                <a:noAutofit/>
              </a:bodyPr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With Recurrence Score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results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br>
                  <a:rPr sz="1400"/>
                </a:b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ode-negativ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711360"/>
                    <a:tab algn="l" pos="1422360"/>
                    <a:tab algn="l" pos="2133720"/>
                    <a:tab algn="l" pos="2844720"/>
                    <a:tab algn="l" pos="3556080"/>
                    <a:tab algn="l" pos="4267080"/>
                    <a:tab algn="l" pos="4978440"/>
                    <a:tab algn="l" pos="5689440"/>
                    <a:tab algn="l" pos="6400800"/>
                    <a:tab algn="l" pos="7112160"/>
                    <a:tab algn="l" pos="7823160"/>
                    <a:tab algn="l" pos="8534520"/>
                    <a:tab algn="l" pos="9245520"/>
                    <a:tab algn="l" pos="9956880"/>
                    <a:tab algn="l" pos="1066788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=40,134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74" name="Straight Arrow Connector 43"/>
            <p:cNvCxnSpPr>
              <a:stCxn id="72" idx="3"/>
              <a:endCxn id="55" idx="1"/>
            </p:cNvCxnSpPr>
            <p:nvPr/>
          </p:nvCxnSpPr>
          <p:spPr>
            <a:xfrm flipV="1">
              <a:off x="5893200" y="4539960"/>
              <a:ext cx="206640" cy="36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lg" type="triangle" w="lg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22T18:29:58Z</dcterms:created>
  <dc:creator>Anna Lau</dc:creator>
  <dc:description/>
  <dc:language>en-US</dc:language>
  <cp:lastModifiedBy>R.Vijitha</cp:lastModifiedBy>
  <dcterms:modified xsi:type="dcterms:W3CDTF">2016-06-02T06:31:46Z</dcterms:modified>
  <cp:revision>16</cp:revision>
  <dc:subject/>
  <dc:title>PowerPoint Presentation</dc:title>
</cp:coreProperties>
</file>